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41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B5A29DA4-91B0-4B7C-B110-7B27B5BFF0A2}"/>
    <pc:docChg chg="delSld">
      <pc:chgData name="Norgard,Dr.,Bobby (DR CI+IM) BIP-US-R" userId="8fb42a27-e12b-430d-ab3b-20c232fde4c7" providerId="ADAL" clId="{B5A29DA4-91B0-4B7C-B110-7B27B5BFF0A2}" dt="2024-05-02T15:22:36.879" v="3" actId="47"/>
      <pc:docMkLst>
        <pc:docMk/>
      </pc:docMkLst>
      <pc:sldChg chg="del">
        <pc:chgData name="Norgard,Dr.,Bobby (DR CI+IM) BIP-US-R" userId="8fb42a27-e12b-430d-ab3b-20c232fde4c7" providerId="ADAL" clId="{B5A29DA4-91B0-4B7C-B110-7B27B5BFF0A2}" dt="2024-05-02T15:22:35.747" v="1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B5A29DA4-91B0-4B7C-B110-7B27B5BFF0A2}" dt="2024-05-02T15:22:34.555" v="0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B5A29DA4-91B0-4B7C-B110-7B27B5BFF0A2}" dt="2024-05-02T15:22:34.555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B5A29DA4-91B0-4B7C-B110-7B27B5BFF0A2}" dt="2024-05-02T15:22:34.555" v="0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B5A29DA4-91B0-4B7C-B110-7B27B5BFF0A2}" dt="2024-05-02T15:22:34.555" v="0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B5A29DA4-91B0-4B7C-B110-7B27B5BFF0A2}" dt="2024-05-02T15:22:34.555" v="0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B5A29DA4-91B0-4B7C-B110-7B27B5BFF0A2}" dt="2024-05-02T15:22:36.879" v="3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B5A29DA4-91B0-4B7C-B110-7B27B5BFF0A2}" dt="2024-05-02T15:22:36.418" v="2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defTabSz="931774">
              <a:defRPr/>
            </a:pPr>
            <a:fld id="{1C04CE70-8047-4961-A4E1-7E2EBE4BCAF5}" type="slidenum">
              <a:rPr lang="en-US">
                <a:solidFill>
                  <a:prstClr val="black"/>
                </a:solidFill>
                <a:latin typeface="Calibri" panose="020F0502020204030204"/>
              </a:rPr>
              <a:pPr defTabSz="931774">
                <a:defRPr/>
              </a:pPr>
              <a:t>1</a:t>
            </a:fld>
            <a:endParaRPr lang="en-US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4423732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E91F578-1CDC-2FDC-1FE0-EF634D5664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922" y="3867150"/>
            <a:ext cx="2552700" cy="14097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8928B61-DFED-210B-E32E-BDA9FC4D4E9A}"/>
              </a:ext>
            </a:extLst>
          </p:cNvPr>
          <p:cNvSpPr txBox="1"/>
          <p:nvPr/>
        </p:nvSpPr>
        <p:spPr>
          <a:xfrm>
            <a:off x="323728" y="1722570"/>
            <a:ext cx="11221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57C23E-4548-E3AC-2184-5E81DC2ACED8}"/>
              </a:ext>
            </a:extLst>
          </p:cNvPr>
          <p:cNvSpPr txBox="1"/>
          <p:nvPr/>
        </p:nvSpPr>
        <p:spPr>
          <a:xfrm>
            <a:off x="3575357" y="1722570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5743A15-43A1-F3B3-78F3-2F594A021B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6279" y="3861999"/>
            <a:ext cx="2209800" cy="135890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0356362F-C863-7400-D19F-8FE1C6CFE3B6}"/>
              </a:ext>
            </a:extLst>
          </p:cNvPr>
          <p:cNvGrpSpPr/>
          <p:nvPr/>
        </p:nvGrpSpPr>
        <p:grpSpPr>
          <a:xfrm>
            <a:off x="3979842" y="2041412"/>
            <a:ext cx="1873270" cy="1193800"/>
            <a:chOff x="3979842" y="2041412"/>
            <a:chExt cx="1873270" cy="1193800"/>
          </a:xfrm>
        </p:grpSpPr>
        <p:pic>
          <p:nvPicPr>
            <p:cNvPr id="1028" name="Picture 4">
              <a:extLst>
                <a:ext uri="{FF2B5EF4-FFF2-40B4-BE49-F238E27FC236}">
                  <a16:creationId xmlns:a16="http://schemas.microsoft.com/office/drawing/2014/main" id="{44B2AE5C-51E7-EEE1-94C7-EC67157885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59680" y="2078162"/>
              <a:ext cx="793432" cy="11420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D645FBF-F799-2658-BDC1-A39BD5551F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" r="43415"/>
            <a:stretch/>
          </p:blipFill>
          <p:spPr>
            <a:xfrm>
              <a:off x="3979842" y="2041412"/>
              <a:ext cx="1077933" cy="1193800"/>
            </a:xfrm>
            <a:prstGeom prst="rect">
              <a:avLst/>
            </a:prstGeom>
          </p:spPr>
        </p:pic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6DB6390C-EC6C-F7E1-62A4-FFB3CA397AB8}"/>
              </a:ext>
            </a:extLst>
          </p:cNvPr>
          <p:cNvSpPr txBox="1"/>
          <p:nvPr/>
        </p:nvSpPr>
        <p:spPr>
          <a:xfrm>
            <a:off x="4588264" y="1863012"/>
            <a:ext cx="751809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i="1" dirty="0"/>
              <a:t>IL6</a:t>
            </a:r>
            <a:r>
              <a:rPr lang="en-US" sz="1400" dirty="0"/>
              <a:t> in </a:t>
            </a:r>
            <a:r>
              <a:rPr lang="en-US" sz="1400" dirty="0" err="1"/>
              <a:t>iCAF</a:t>
            </a:r>
            <a:endParaRPr 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E1E0329-CFF5-6CAF-C502-F29ECE683894}"/>
              </a:ext>
            </a:extLst>
          </p:cNvPr>
          <p:cNvSpPr txBox="1"/>
          <p:nvPr/>
        </p:nvSpPr>
        <p:spPr>
          <a:xfrm>
            <a:off x="978047" y="3709670"/>
            <a:ext cx="192706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M1 macrophage marker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C31AEB-E7A8-D7A3-931E-9DB10BB6D062}"/>
              </a:ext>
            </a:extLst>
          </p:cNvPr>
          <p:cNvSpPr txBox="1"/>
          <p:nvPr/>
        </p:nvSpPr>
        <p:spPr>
          <a:xfrm>
            <a:off x="3979842" y="3709670"/>
            <a:ext cx="260404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Dendritic cell maturation marker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8FFCB86-096E-862D-09D1-68F9A119514E}"/>
              </a:ext>
            </a:extLst>
          </p:cNvPr>
          <p:cNvSpPr txBox="1"/>
          <p:nvPr/>
        </p:nvSpPr>
        <p:spPr>
          <a:xfrm>
            <a:off x="323728" y="3537072"/>
            <a:ext cx="11541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C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F8AF5F9-4F78-2074-F147-76630734520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2664" y="1989601"/>
            <a:ext cx="1943100" cy="13335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950CC76-28A1-3D3A-C653-D3826EEFE75C}"/>
              </a:ext>
            </a:extLst>
          </p:cNvPr>
          <p:cNvSpPr txBox="1"/>
          <p:nvPr/>
        </p:nvSpPr>
        <p:spPr>
          <a:xfrm>
            <a:off x="1046508" y="1837272"/>
            <a:ext cx="151689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i="1" dirty="0"/>
              <a:t>Ccr2</a:t>
            </a:r>
            <a:r>
              <a:rPr lang="en-US" sz="1400" dirty="0"/>
              <a:t> in macrophage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180BA8-35EE-1AD0-2BB2-D81443429AB5}"/>
              </a:ext>
            </a:extLst>
          </p:cNvPr>
          <p:cNvSpPr txBox="1"/>
          <p:nvPr/>
        </p:nvSpPr>
        <p:spPr>
          <a:xfrm>
            <a:off x="3575357" y="3537072"/>
            <a:ext cx="12343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B917A74-D0EB-3320-B4A6-BD9AE8BAC2DF}"/>
              </a:ext>
            </a:extLst>
          </p:cNvPr>
          <p:cNvSpPr txBox="1"/>
          <p:nvPr/>
        </p:nvSpPr>
        <p:spPr>
          <a:xfrm>
            <a:off x="303880" y="6586151"/>
            <a:ext cx="60969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 expression of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cr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macrophages before and after SOS1i+MEKi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 expression of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L6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CAFs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efore and after SOS1i+MEKi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 expression of M1 macrophage markers before and after SOS1i+MEKi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 expression of dendritic cell maturation markers before and after SOS1i+MEKi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itle 2">
            <a:extLst>
              <a:ext uri="{FF2B5EF4-FFF2-40B4-BE49-F238E27FC236}">
                <a16:creationId xmlns:a16="http://schemas.microsoft.com/office/drawing/2014/main" id="{ACA4ED10-B11F-F3EB-9FF2-2CE5CFE79C5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1380050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</TotalTime>
  <Words>85</Words>
  <Application>Microsoft Office PowerPoint</Application>
  <PresentationFormat>Letter Paper (8.5x11 in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2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